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879725" cy="360045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ADB60B-61C3-40AA-93BC-DCBADED6B6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44000" y="841320"/>
            <a:ext cx="25909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44000" y="2082960"/>
            <a:ext cx="25909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7639A-1101-4B41-9B10-42B637C32C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44000" y="84132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472040" y="84132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44000" y="208296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472040" y="208296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7406E-E376-4AE8-9959-01C653B20C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44000" y="841320"/>
            <a:ext cx="8341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020240" y="841320"/>
            <a:ext cx="8341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96480" y="841320"/>
            <a:ext cx="8341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44000" y="2082960"/>
            <a:ext cx="8341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020240" y="2082960"/>
            <a:ext cx="8341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896480" y="2082960"/>
            <a:ext cx="8341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E8771-29E4-4E0C-A7DD-92868EBD17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44000" y="841320"/>
            <a:ext cx="2590920" cy="237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24"/>
              </a:spcBef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D12AD-442A-4BC5-B1FF-16F8DC411E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44000" y="841320"/>
            <a:ext cx="2590920" cy="23767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9AF3A-BB5E-4E86-915A-2A4EA24740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44000" y="841320"/>
            <a:ext cx="1264320" cy="23767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472040" y="841320"/>
            <a:ext cx="1264320" cy="23767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8D279-E262-4420-A526-956E10BD91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DA9787-5978-4057-954C-014346835F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44000" y="144000"/>
            <a:ext cx="2590920" cy="2783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24"/>
              </a:spcBef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8BE47-28A7-4728-A0A1-497CFFBB1E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44000" y="84132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472040" y="841320"/>
            <a:ext cx="1264320" cy="23767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44000" y="208296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63F81-478C-4B2E-B68F-A07466AAAE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44000" y="841320"/>
            <a:ext cx="1264320" cy="23767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472040" y="84132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472040" y="208296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95C2D-8EF2-4B92-A809-EF53E00C00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44000" y="84132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472040" y="841320"/>
            <a:ext cx="12643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44000" y="2082960"/>
            <a:ext cx="2590920" cy="113364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indent="0">
              <a:spcBef>
                <a:spcPts val="224"/>
              </a:spcBef>
              <a:buNone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11C93-3431-49FB-A342-EE3D38D0D0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44000" y="144000"/>
            <a:ext cx="2590920" cy="6001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ctr">
            <a:noAutofit/>
          </a:bodyPr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44000" y="841320"/>
            <a:ext cx="2590920" cy="237672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rmAutofit/>
          </a:bodyPr>
          <a:p>
            <a:pPr marL="100080" indent="-100080">
              <a:spcBef>
                <a:spcPts val="224"/>
              </a:spcBef>
              <a:buClr>
                <a:srgbClr val="000000"/>
              </a:buClr>
              <a:buFont typeface="Arial"/>
              <a:buChar char="•"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1" marL="217440" indent="-84240">
              <a:spcBef>
                <a:spcPts val="224"/>
              </a:spcBef>
              <a:buClr>
                <a:srgbClr val="000000"/>
              </a:buClr>
              <a:buFont typeface="Arial"/>
              <a:buChar char="–"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2" marL="334800" indent="-68040">
              <a:spcBef>
                <a:spcPts val="224"/>
              </a:spcBef>
              <a:buClr>
                <a:srgbClr val="000000"/>
              </a:buClr>
              <a:buFont typeface="Arial"/>
              <a:buChar char="•"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3" marL="468360" indent="-66600">
              <a:spcBef>
                <a:spcPts val="224"/>
              </a:spcBef>
              <a:buClr>
                <a:srgbClr val="000000"/>
              </a:buClr>
              <a:buFont typeface="Arial"/>
              <a:buChar char="–"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4" marL="601560" indent="-66600">
              <a:spcBef>
                <a:spcPts val="224"/>
              </a:spcBef>
              <a:buClr>
                <a:srgbClr val="000000"/>
              </a:buClr>
              <a:buFont typeface="Arial"/>
              <a:buChar char="»"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5" marL="601560" indent="-66600">
              <a:spcBef>
                <a:spcPts val="224"/>
              </a:spcBef>
              <a:buClr>
                <a:srgbClr val="000000"/>
              </a:buClr>
              <a:buFont typeface="Arial"/>
              <a:buChar char="»"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6" marL="601560" indent="-66600">
              <a:spcBef>
                <a:spcPts val="224"/>
              </a:spcBef>
              <a:buClr>
                <a:srgbClr val="000000"/>
              </a:buClr>
              <a:buFont typeface="Arial"/>
              <a:buChar char="»"/>
              <a:tabLst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44360" y="3281400"/>
            <a:ext cx="671760" cy="24768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Autofit/>
          </a:bodyPr>
          <a:lstStyle>
            <a:lvl1pPr indent="0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  <a:defRPr b="0" lang="en-US" sz="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983880" y="3281400"/>
            <a:ext cx="911160" cy="24768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Autofit/>
          </a:bodyPr>
          <a:lstStyle>
            <a:lvl1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  <a:defRPr b="0" lang="en-US" sz="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063520" y="3281400"/>
            <a:ext cx="671400" cy="247680"/>
          </a:xfrm>
          <a:prstGeom prst="rect">
            <a:avLst/>
          </a:prstGeom>
          <a:noFill/>
          <a:ln w="0">
            <a:noFill/>
          </a:ln>
        </p:spPr>
        <p:txBody>
          <a:bodyPr lIns="26640" rIns="26640" tIns="13320" bIns="13320" anchor="t">
            <a:noAutofit/>
          </a:bodyPr>
          <a:lstStyle>
            <a:lvl1pPr indent="0" algn="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  <a:defRPr b="0" lang="en-US" sz="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266760"/>
                <a:tab algn="l" pos="533520"/>
                <a:tab algn="l" pos="800280"/>
                <a:tab algn="l" pos="1066680"/>
                <a:tab algn="l" pos="1333440"/>
                <a:tab algn="l" pos="1600200"/>
                <a:tab algn="l" pos="1866960"/>
                <a:tab algn="l" pos="2133720"/>
                <a:tab algn="l" pos="2400480"/>
                <a:tab algn="l" pos="2666880"/>
                <a:tab algn="l" pos="2933640"/>
                <a:tab algn="l" pos="3200400"/>
                <a:tab algn="l" pos="3467160"/>
                <a:tab algn="l" pos="3733920"/>
                <a:tab algn="l" pos="4000680"/>
                <a:tab algn="l" pos="4267080"/>
                <a:tab algn="l" pos="4533840"/>
                <a:tab algn="l" pos="4800600"/>
                <a:tab algn="l" pos="5067360"/>
                <a:tab algn="l" pos="5334120"/>
              </a:tabLst>
            </a:pPr>
            <a:fld id="{EF7B0954-1FC9-4F9B-A510-9F719FCBCF4E}" type="slidenum">
              <a:rPr b="0" lang="en-US" sz="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0" y="0"/>
            <a:ext cx="2879640" cy="3606480"/>
            <a:chOff x="0" y="0"/>
            <a:chExt cx="2879640" cy="3606480"/>
          </a:xfrm>
        </p:grpSpPr>
        <p:grpSp>
          <p:nvGrpSpPr>
            <p:cNvPr id="42" name=""/>
            <p:cNvGrpSpPr/>
            <p:nvPr/>
          </p:nvGrpSpPr>
          <p:grpSpPr>
            <a:xfrm>
              <a:off x="0" y="304920"/>
              <a:ext cx="2879640" cy="1288800"/>
              <a:chOff x="0" y="304920"/>
              <a:chExt cx="2879640" cy="128880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0" y="304920"/>
                <a:ext cx="2879640" cy="1288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"/>
              <p:cNvSpPr/>
              <p:nvPr/>
            </p:nvSpPr>
            <p:spPr>
              <a:xfrm>
                <a:off x="431640" y="1015200"/>
                <a:ext cx="432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D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647640" y="611640"/>
                <a:ext cx="3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666720" y="353160"/>
                <a:ext cx="432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2448000" y="551880"/>
                <a:ext cx="3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1952640" y="439920"/>
                <a:ext cx="36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521000" y="951120"/>
                <a:ext cx="431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SC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0" name=""/>
            <p:cNvSpPr/>
            <p:nvPr/>
          </p:nvSpPr>
          <p:spPr>
            <a:xfrm>
              <a:off x="1440" y="1206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6760"/>
                  <a:tab algn="l" pos="533520"/>
                  <a:tab algn="l" pos="800280"/>
                  <a:tab algn="l" pos="1066680"/>
                  <a:tab algn="l" pos="1333440"/>
                  <a:tab algn="l" pos="1600200"/>
                  <a:tab algn="l" pos="1866960"/>
                  <a:tab algn="l" pos="2133720"/>
                  <a:tab algn="l" pos="2400480"/>
                  <a:tab algn="l" pos="2666880"/>
                  <a:tab algn="l" pos="2933640"/>
                  <a:tab algn="l" pos="3200400"/>
                  <a:tab algn="l" pos="3467160"/>
                  <a:tab algn="l" pos="3733920"/>
                  <a:tab algn="l" pos="4000680"/>
                  <a:tab algn="l" pos="4267080"/>
                  <a:tab algn="l" pos="4533840"/>
                  <a:tab algn="l" pos="4800600"/>
                  <a:tab algn="l" pos="5067360"/>
                  <a:tab algn="l" pos="53341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371600" y="1206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6760"/>
                  <a:tab algn="l" pos="533520"/>
                  <a:tab algn="l" pos="800280"/>
                  <a:tab algn="l" pos="1066680"/>
                  <a:tab algn="l" pos="1333440"/>
                  <a:tab algn="l" pos="1600200"/>
                  <a:tab algn="l" pos="1866960"/>
                  <a:tab algn="l" pos="2133720"/>
                  <a:tab algn="l" pos="2400480"/>
                  <a:tab algn="l" pos="2666880"/>
                  <a:tab algn="l" pos="2933640"/>
                  <a:tab algn="l" pos="3200400"/>
                  <a:tab algn="l" pos="3467160"/>
                  <a:tab algn="l" pos="3733920"/>
                  <a:tab algn="l" pos="4000680"/>
                  <a:tab algn="l" pos="4267080"/>
                  <a:tab algn="l" pos="4533840"/>
                  <a:tab algn="l" pos="4800600"/>
                  <a:tab algn="l" pos="5067360"/>
                  <a:tab algn="l" pos="53341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450800" y="0"/>
              <a:ext cx="141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246240"/>
                  <a:tab algn="l" pos="492120"/>
                  <a:tab algn="l" pos="738360"/>
                  <a:tab algn="l" pos="984240"/>
                  <a:tab algn="l" pos="1230480"/>
                  <a:tab algn="l" pos="1476360"/>
                  <a:tab algn="l" pos="1722600"/>
                  <a:tab algn="l" pos="1968480"/>
                  <a:tab algn="l" pos="2214720"/>
                  <a:tab algn="l" pos="2460600"/>
                  <a:tab algn="l" pos="2706840"/>
                  <a:tab algn="l" pos="2952720"/>
                  <a:tab algn="l" pos="3198960"/>
                  <a:tab algn="l" pos="3444840"/>
                  <a:tab algn="l" pos="3691080"/>
                  <a:tab algn="l" pos="3936960"/>
                  <a:tab algn="l" pos="4183200"/>
                  <a:tab algn="l" pos="4429080"/>
                  <a:tab algn="l" pos="4675320"/>
                  <a:tab algn="l" pos="4921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Irigoyen et al Add. Fig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7920" y="157464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6760"/>
                  <a:tab algn="l" pos="533520"/>
                  <a:tab algn="l" pos="800280"/>
                  <a:tab algn="l" pos="1066680"/>
                  <a:tab algn="l" pos="1333440"/>
                  <a:tab algn="l" pos="1600200"/>
                  <a:tab algn="l" pos="1866960"/>
                  <a:tab algn="l" pos="2133720"/>
                  <a:tab algn="l" pos="2400480"/>
                  <a:tab algn="l" pos="2666880"/>
                  <a:tab algn="l" pos="2933640"/>
                  <a:tab algn="l" pos="3200400"/>
                  <a:tab algn="l" pos="3467160"/>
                  <a:tab algn="l" pos="3733920"/>
                  <a:tab algn="l" pos="4000680"/>
                  <a:tab algn="l" pos="4267080"/>
                  <a:tab algn="l" pos="4533840"/>
                  <a:tab algn="l" pos="4800600"/>
                  <a:tab algn="l" pos="5067360"/>
                  <a:tab algn="l" pos="53341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4" name=""/>
            <p:cNvGrpSpPr/>
            <p:nvPr/>
          </p:nvGrpSpPr>
          <p:grpSpPr>
            <a:xfrm>
              <a:off x="266760" y="1763640"/>
              <a:ext cx="2379600" cy="1148760"/>
              <a:chOff x="266760" y="1763640"/>
              <a:chExt cx="2379600" cy="1148760"/>
            </a:xfrm>
          </p:grpSpPr>
          <p:sp>
            <p:nvSpPr>
              <p:cNvPr id="55" name=""/>
              <p:cNvSpPr/>
              <p:nvPr/>
            </p:nvSpPr>
            <p:spPr>
              <a:xfrm>
                <a:off x="266760" y="2166840"/>
                <a:ext cx="363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534960" y="2174760"/>
                <a:ext cx="1469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041480" y="2136600"/>
                <a:ext cx="522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SC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58920" y="2734920"/>
                <a:ext cx="1042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693720" y="2696760"/>
                <a:ext cx="522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D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770120" y="2692080"/>
                <a:ext cx="39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403280" y="2695320"/>
                <a:ext cx="38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L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952640" y="1763640"/>
                <a:ext cx="693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TGFB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1952640" y="1946160"/>
                <a:ext cx="693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l-GR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1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acti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952640" y="2338200"/>
                <a:ext cx="693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TGFB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1952640" y="2509560"/>
                <a:ext cx="693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66760"/>
                    <a:tab algn="l" pos="533520"/>
                    <a:tab algn="l" pos="800280"/>
                    <a:tab algn="l" pos="1066680"/>
                    <a:tab algn="l" pos="1333440"/>
                    <a:tab algn="l" pos="1600200"/>
                    <a:tab algn="l" pos="1866960"/>
                    <a:tab algn="l" pos="2133720"/>
                    <a:tab algn="l" pos="2400480"/>
                    <a:tab algn="l" pos="2666880"/>
                    <a:tab algn="l" pos="2933640"/>
                    <a:tab algn="l" pos="3200400"/>
                    <a:tab algn="l" pos="3467160"/>
                    <a:tab algn="l" pos="3733920"/>
                    <a:tab algn="l" pos="4000680"/>
                    <a:tab algn="l" pos="4267080"/>
                    <a:tab algn="l" pos="4533840"/>
                    <a:tab algn="l" pos="4800600"/>
                    <a:tab algn="l" pos="5067360"/>
                    <a:tab algn="l" pos="5334120"/>
                  </a:tabLst>
                </a:pPr>
                <a:r>
                  <a:rPr b="1" lang="el-GR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1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acti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1441440" y="2734920"/>
                <a:ext cx="309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7" name="" descr=""/>
              <p:cNvPicPr/>
              <p:nvPr/>
            </p:nvPicPr>
            <p:blipFill>
              <a:blip r:embed="rId2">
                <a:lum bright="-6000"/>
              </a:blip>
              <a:stretch/>
            </p:blipFill>
            <p:spPr>
              <a:xfrm>
                <a:off x="347760" y="2379600"/>
                <a:ext cx="1663560" cy="1332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68" name="" descr=""/>
              <p:cNvPicPr/>
              <p:nvPr/>
            </p:nvPicPr>
            <p:blipFill>
              <a:blip r:embed="rId3">
                <a:lum bright="-6000"/>
              </a:blip>
              <a:stretch/>
            </p:blipFill>
            <p:spPr>
              <a:xfrm>
                <a:off x="343080" y="2558880"/>
                <a:ext cx="1663560" cy="12996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69" name="" descr=""/>
              <p:cNvPicPr/>
              <p:nvPr/>
            </p:nvPicPr>
            <p:blipFill>
              <a:blip r:embed="rId4">
                <a:lum bright="-6000"/>
              </a:blip>
              <a:stretch/>
            </p:blipFill>
            <p:spPr>
              <a:xfrm>
                <a:off x="345960" y="1788840"/>
                <a:ext cx="1662120" cy="14292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70" name="" descr=""/>
              <p:cNvPicPr/>
              <p:nvPr/>
            </p:nvPicPr>
            <p:blipFill>
              <a:blip r:embed="rId5">
                <a:lum bright="-6000"/>
              </a:blip>
              <a:stretch/>
            </p:blipFill>
            <p:spPr>
              <a:xfrm>
                <a:off x="344520" y="1981080"/>
                <a:ext cx="1663560" cy="1458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</p:grpSp>
        <p:grpSp>
          <p:nvGrpSpPr>
            <p:cNvPr id="71" name=""/>
            <p:cNvGrpSpPr/>
            <p:nvPr/>
          </p:nvGrpSpPr>
          <p:grpSpPr>
            <a:xfrm>
              <a:off x="264600" y="3059280"/>
              <a:ext cx="2216520" cy="547200"/>
              <a:chOff x="264600" y="3059280"/>
              <a:chExt cx="2216520" cy="547200"/>
            </a:xfrm>
          </p:grpSpPr>
          <p:sp>
            <p:nvSpPr>
              <p:cNvPr id="72" name=""/>
              <p:cNvSpPr/>
              <p:nvPr/>
            </p:nvSpPr>
            <p:spPr>
              <a:xfrm>
                <a:off x="264600" y="3390840"/>
                <a:ext cx="464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246240"/>
                    <a:tab algn="l" pos="492120"/>
                    <a:tab algn="l" pos="738360"/>
                    <a:tab algn="l" pos="984240"/>
                    <a:tab algn="l" pos="1230480"/>
                    <a:tab algn="l" pos="1476360"/>
                    <a:tab algn="l" pos="1722600"/>
                    <a:tab algn="l" pos="1968480"/>
                    <a:tab algn="l" pos="2214720"/>
                    <a:tab algn="l" pos="2460600"/>
                    <a:tab algn="l" pos="2706840"/>
                    <a:tab algn="l" pos="2952720"/>
                    <a:tab algn="l" pos="3198960"/>
                    <a:tab algn="l" pos="3444840"/>
                    <a:tab algn="l" pos="3691080"/>
                    <a:tab algn="l" pos="3936960"/>
                    <a:tab algn="l" pos="4183200"/>
                    <a:tab algn="l" pos="4429080"/>
                    <a:tab algn="l" pos="4675320"/>
                    <a:tab algn="l" pos="4921200"/>
                  </a:tabLst>
                </a:pPr>
                <a:r>
                  <a:rPr b="1" lang="es-ES" sz="800" spc="-1" strike="noStrike">
                    <a:solidFill>
                      <a:srgbClr val="000000"/>
                    </a:solidFill>
                    <a:latin typeface="Arial"/>
                  </a:rPr>
                  <a:t>SAE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1187280" y="3225600"/>
                <a:ext cx="1293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46240"/>
                    <a:tab algn="l" pos="492120"/>
                    <a:tab algn="l" pos="738360"/>
                    <a:tab algn="l" pos="984240"/>
                    <a:tab algn="l" pos="1230480"/>
                    <a:tab algn="l" pos="1476360"/>
                    <a:tab algn="l" pos="1722600"/>
                    <a:tab algn="l" pos="1968480"/>
                    <a:tab algn="l" pos="2214720"/>
                    <a:tab algn="l" pos="2460600"/>
                    <a:tab algn="l" pos="2706840"/>
                    <a:tab algn="l" pos="2952720"/>
                    <a:tab algn="l" pos="3198960"/>
                    <a:tab algn="l" pos="3444840"/>
                    <a:tab algn="l" pos="3691080"/>
                    <a:tab algn="l" pos="3936960"/>
                    <a:tab algn="l" pos="4183200"/>
                    <a:tab algn="l" pos="4429080"/>
                    <a:tab algn="l" pos="4675320"/>
                    <a:tab algn="l" pos="4921200"/>
                  </a:tabLst>
                </a:pPr>
                <a:r>
                  <a:rPr b="1" lang="es-E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ilver staining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4" name="" descr=""/>
              <p:cNvPicPr/>
              <p:nvPr/>
            </p:nvPicPr>
            <p:blipFill>
              <a:blip r:embed="rId6"/>
              <a:srcRect l="3785" t="10446" r="0" b="15958"/>
              <a:stretch/>
            </p:blipFill>
            <p:spPr>
              <a:xfrm>
                <a:off x="341280" y="3095640"/>
                <a:ext cx="895320" cy="13608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sp>
            <p:nvSpPr>
              <p:cNvPr id="75" name=""/>
              <p:cNvSpPr/>
              <p:nvPr/>
            </p:nvSpPr>
            <p:spPr>
              <a:xfrm>
                <a:off x="1182600" y="3059280"/>
                <a:ext cx="81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246240"/>
                    <a:tab algn="l" pos="492120"/>
                    <a:tab algn="l" pos="738360"/>
                    <a:tab algn="l" pos="984240"/>
                    <a:tab algn="l" pos="1230480"/>
                    <a:tab algn="l" pos="1476360"/>
                    <a:tab algn="l" pos="1722600"/>
                    <a:tab algn="l" pos="1968480"/>
                    <a:tab algn="l" pos="2214720"/>
                    <a:tab algn="l" pos="2460600"/>
                    <a:tab algn="l" pos="2706840"/>
                    <a:tab algn="l" pos="2952720"/>
                    <a:tab algn="l" pos="3198960"/>
                    <a:tab algn="l" pos="3444840"/>
                    <a:tab algn="l" pos="3691080"/>
                    <a:tab algn="l" pos="3936960"/>
                    <a:tab algn="l" pos="4183200"/>
                    <a:tab algn="l" pos="4429080"/>
                    <a:tab algn="l" pos="4675320"/>
                    <a:tab algn="l" pos="49212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TGFB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6" name="" descr=""/>
              <p:cNvPicPr/>
              <p:nvPr/>
            </p:nvPicPr>
            <p:blipFill>
              <a:blip r:embed="rId7"/>
              <a:stretch/>
            </p:blipFill>
            <p:spPr>
              <a:xfrm>
                <a:off x="343080" y="3265560"/>
                <a:ext cx="893520" cy="13752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sp>
            <p:nvSpPr>
              <p:cNvPr id="77" name=""/>
              <p:cNvSpPr/>
              <p:nvPr/>
            </p:nvSpPr>
            <p:spPr>
              <a:xfrm>
                <a:off x="904320" y="3390840"/>
                <a:ext cx="423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246240"/>
                    <a:tab algn="l" pos="492120"/>
                    <a:tab algn="l" pos="738360"/>
                    <a:tab algn="l" pos="984240"/>
                    <a:tab algn="l" pos="1230480"/>
                    <a:tab algn="l" pos="1476360"/>
                    <a:tab algn="l" pos="1722600"/>
                    <a:tab algn="l" pos="1968480"/>
                    <a:tab algn="l" pos="2214720"/>
                    <a:tab algn="l" pos="2460600"/>
                    <a:tab algn="l" pos="2706840"/>
                    <a:tab algn="l" pos="2952720"/>
                    <a:tab algn="l" pos="3198960"/>
                    <a:tab algn="l" pos="3444840"/>
                    <a:tab algn="l" pos="3691080"/>
                    <a:tab algn="l" pos="3936960"/>
                    <a:tab algn="l" pos="4183200"/>
                    <a:tab algn="l" pos="4429080"/>
                    <a:tab algn="l" pos="4675320"/>
                    <a:tab algn="l" pos="4921200"/>
                  </a:tabLst>
                </a:pPr>
                <a:r>
                  <a:rPr b="1" lang="es-ES" sz="800" spc="-1" strike="noStrike">
                    <a:solidFill>
                      <a:srgbClr val="000000"/>
                    </a:solidFill>
                    <a:latin typeface="Arial"/>
                  </a:rPr>
                  <a:t>A54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561960" y="3390840"/>
                <a:ext cx="479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246240"/>
                    <a:tab algn="l" pos="492120"/>
                    <a:tab algn="l" pos="738360"/>
                    <a:tab algn="l" pos="984240"/>
                    <a:tab algn="l" pos="1230480"/>
                    <a:tab algn="l" pos="1476360"/>
                    <a:tab algn="l" pos="1722600"/>
                    <a:tab algn="l" pos="1968480"/>
                    <a:tab algn="l" pos="2214720"/>
                    <a:tab algn="l" pos="2460600"/>
                    <a:tab algn="l" pos="2706840"/>
                    <a:tab algn="l" pos="2952720"/>
                    <a:tab algn="l" pos="3198960"/>
                    <a:tab algn="l" pos="3444840"/>
                    <a:tab algn="l" pos="3691080"/>
                    <a:tab algn="l" pos="3936960"/>
                    <a:tab algn="l" pos="4183200"/>
                    <a:tab algn="l" pos="4429080"/>
                    <a:tab algn="l" pos="4675320"/>
                    <a:tab algn="l" pos="4921200"/>
                  </a:tabLst>
                </a:pPr>
                <a:r>
                  <a:rPr b="1" lang="es-ES" sz="800" spc="-1" strike="noStrike">
                    <a:solidFill>
                      <a:srgbClr val="000000"/>
                    </a:solidFill>
                    <a:latin typeface="Arial"/>
                  </a:rPr>
                  <a:t>H12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9" name=""/>
            <p:cNvSpPr/>
            <p:nvPr/>
          </p:nvSpPr>
          <p:spPr>
            <a:xfrm>
              <a:off x="9360" y="28782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266760"/>
                  <a:tab algn="l" pos="533520"/>
                  <a:tab algn="l" pos="800280"/>
                  <a:tab algn="l" pos="1066680"/>
                  <a:tab algn="l" pos="1333440"/>
                  <a:tab algn="l" pos="1600200"/>
                  <a:tab algn="l" pos="1866960"/>
                  <a:tab algn="l" pos="2133720"/>
                  <a:tab algn="l" pos="2400480"/>
                  <a:tab algn="l" pos="2666880"/>
                  <a:tab algn="l" pos="2933640"/>
                  <a:tab algn="l" pos="3200400"/>
                  <a:tab algn="l" pos="3467160"/>
                  <a:tab algn="l" pos="3733920"/>
                  <a:tab algn="l" pos="4000680"/>
                  <a:tab algn="l" pos="4267080"/>
                  <a:tab algn="l" pos="4533840"/>
                  <a:tab algn="l" pos="4800600"/>
                  <a:tab algn="l" pos="5067360"/>
                  <a:tab algn="l" pos="53341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4T11:17:33Z</dcterms:created>
  <dc:creator>Marta</dc:creator>
  <dc:description/>
  <dc:language>en-US</dc:language>
  <cp:lastModifiedBy>Centro de Tecnología Informática</cp:lastModifiedBy>
  <dcterms:modified xsi:type="dcterms:W3CDTF">2010-05-19T10:43:07Z</dcterms:modified>
  <cp:revision>24</cp:revision>
  <dc:subject/>
  <dc:title>Diapositiva 1</dc:title>
</cp:coreProperties>
</file>